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7004E-B3CB-49F7-B812-75D1C9AD85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0BEAF-4635-492C-86AB-25D19F90EB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D27D2-50DC-4786-9EEE-10F571331C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F2E5B-87AF-42BA-BB6E-DFFDAF2CBD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BD80B-D9CE-495E-96F7-E48DAFFA8D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D972C-9333-43B1-99CB-C04961968D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821C1-7E53-483A-9FD3-BE42A716D1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6DE2F-DE08-46F4-A033-22CCD8AC58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3482E-27B6-49E5-9995-0DB27EC1A3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E5734-B70E-45EB-9B6B-BAF8794E4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69CAB-81B4-4B16-99C6-5CD931B894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FCE157-F61D-4D23-903A-2BC4A15D97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36C614-790C-44CE-B852-364EDF5EF40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765240" y="836640"/>
            <a:ext cx="2190960" cy="3589560"/>
            <a:chOff x="3765240" y="836640"/>
            <a:chExt cx="2190960" cy="35895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19794" t="0" r="0" b="0"/>
            <a:stretch/>
          </p:blipFill>
          <p:spPr>
            <a:xfrm>
              <a:off x="3791160" y="836640"/>
              <a:ext cx="2165040" cy="306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3765240" y="3875040"/>
              <a:ext cx="206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W     P       C        P       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336920" y="4149720"/>
              <a:ext cx="57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222880" y="4149720"/>
              <a:ext cx="57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410000" y="4149720"/>
              <a:ext cx="47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 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275080" y="4149720"/>
              <a:ext cx="47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S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2195640" y="4416480"/>
            <a:ext cx="6121440" cy="22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. Influence of signal sequence presence on YedY cellular localiz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eriplasmic (P) and cytoplasmic (C) extracts (25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)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. sphaeroid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arboring plasmids pSM181 (N-ter tagged YedY lacking signal sequence) and pSM196 (N-ter tagged YedY with the signal sequence) were separated by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DS PAGE and analyzed by western blot with anti-histidine peroxidas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jugate antibodies. Even though YedY is present in both samples due to cross-contamination during extract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eparation, these results demonstrate that the enzyme is localized to th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ytoplasm in th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bsence of signal sequence (-SS), while in the presence of signal sequence (+SS) the enzyme i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edominantly translocated to the periplas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5T13:49:08Z</dcterms:created>
  <dc:creator>CEA</dc:creator>
  <dc:description/>
  <dc:language>en-US</dc:language>
  <cp:lastModifiedBy>CEA</cp:lastModifiedBy>
  <dcterms:modified xsi:type="dcterms:W3CDTF">2013-09-19T11:43:37Z</dcterms:modified>
  <cp:revision>2</cp:revision>
  <dc:subject/>
  <dc:title>Diapositive 1</dc:title>
</cp:coreProperties>
</file>